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49287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042" autoAdjust="0"/>
    <p:restoredTop sz="94660"/>
  </p:normalViewPr>
  <p:slideViewPr>
    <p:cSldViewPr snapToGrid="0">
      <p:cViewPr varScale="1">
        <p:scale>
          <a:sx n="71" d="100"/>
          <a:sy n="71" d="100"/>
        </p:scale>
        <p:origin x="52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02EFE9-E17E-48A4-BD8A-CA79ACF7271C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229D6-103D-4C95-91C8-A567FA2A8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0895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496484"/>
            <a:ext cx="5518944" cy="3183467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4802717"/>
            <a:ext cx="4869656" cy="2207683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00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847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486834"/>
            <a:ext cx="140002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486834"/>
            <a:ext cx="4118918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55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46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2279653"/>
            <a:ext cx="5600105" cy="3803649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6119286"/>
            <a:ext cx="5600105" cy="200024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>
                    <a:tint val="82000"/>
                  </a:schemeClr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82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82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104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76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86836"/>
            <a:ext cx="560010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2241551"/>
            <a:ext cx="2746790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3340100"/>
            <a:ext cx="274679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2241551"/>
            <a:ext cx="2760318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3340100"/>
            <a:ext cx="276031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38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42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1316569"/>
            <a:ext cx="3287018" cy="6498167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20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1316569"/>
            <a:ext cx="3287018" cy="6498167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533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486836"/>
            <a:ext cx="560010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2434167"/>
            <a:ext cx="560010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8475136"/>
            <a:ext cx="219134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140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ACD28EA-8875-B8A4-0144-A0946E1934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0365544"/>
              </p:ext>
            </p:extLst>
          </p:nvPr>
        </p:nvGraphicFramePr>
        <p:xfrm>
          <a:off x="307074" y="998658"/>
          <a:ext cx="6018663" cy="5317374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66383">
                  <a:extLst>
                    <a:ext uri="{9D8B030D-6E8A-4147-A177-3AD203B41FA5}">
                      <a16:colId xmlns:a16="http://schemas.microsoft.com/office/drawing/2014/main" val="325495034"/>
                    </a:ext>
                  </a:extLst>
                </a:gridCol>
                <a:gridCol w="937926">
                  <a:extLst>
                    <a:ext uri="{9D8B030D-6E8A-4147-A177-3AD203B41FA5}">
                      <a16:colId xmlns:a16="http://schemas.microsoft.com/office/drawing/2014/main" val="1015727869"/>
                    </a:ext>
                  </a:extLst>
                </a:gridCol>
                <a:gridCol w="863578">
                  <a:extLst>
                    <a:ext uri="{9D8B030D-6E8A-4147-A177-3AD203B41FA5}">
                      <a16:colId xmlns:a16="http://schemas.microsoft.com/office/drawing/2014/main" val="276049191"/>
                    </a:ext>
                  </a:extLst>
                </a:gridCol>
                <a:gridCol w="1160060">
                  <a:extLst>
                    <a:ext uri="{9D8B030D-6E8A-4147-A177-3AD203B41FA5}">
                      <a16:colId xmlns:a16="http://schemas.microsoft.com/office/drawing/2014/main" val="2664999566"/>
                    </a:ext>
                  </a:extLst>
                </a:gridCol>
                <a:gridCol w="1201003">
                  <a:extLst>
                    <a:ext uri="{9D8B030D-6E8A-4147-A177-3AD203B41FA5}">
                      <a16:colId xmlns:a16="http://schemas.microsoft.com/office/drawing/2014/main" val="3467369409"/>
                    </a:ext>
                  </a:extLst>
                </a:gridCol>
                <a:gridCol w="1289713">
                  <a:extLst>
                    <a:ext uri="{9D8B030D-6E8A-4147-A177-3AD203B41FA5}">
                      <a16:colId xmlns:a16="http://schemas.microsoft.com/office/drawing/2014/main" val="2321364895"/>
                    </a:ext>
                  </a:extLst>
                </a:gridCol>
              </a:tblGrid>
              <a:tr h="223628"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Patient ID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CAR T/Non CAR 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</a:rPr>
                        <a:t>Identity(%) </a:t>
                      </a:r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</a:rPr>
                        <a:t>  80%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</a:rPr>
                        <a:t>Potency(%) </a:t>
                      </a:r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</a:rPr>
                        <a:t> 10%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</a:rPr>
                        <a:t>Viability(%) </a:t>
                      </a:r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sz="700" b="1" kern="1200" dirty="0">
                          <a:solidFill>
                            <a:schemeClr val="lt1"/>
                          </a:solidFill>
                          <a:effectLst/>
                        </a:rPr>
                        <a:t>70%@Day14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Expansion folds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2188895071"/>
                  </a:ext>
                </a:extLst>
              </a:tr>
              <a:tr h="417914">
                <a:tc rowSpan="2"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QNS985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Non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8.5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0.33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4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38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4059160118"/>
                  </a:ext>
                </a:extLst>
              </a:tr>
              <a:tr h="41791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MC9999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8.9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58.3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2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46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2636318392"/>
                  </a:ext>
                </a:extLst>
              </a:tr>
              <a:tr h="417914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</a:rPr>
                        <a:t>QNS986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Non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9.4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0.82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8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140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1516382909"/>
                  </a:ext>
                </a:extLst>
              </a:tr>
              <a:tr h="41791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MC9999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9.0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34.9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1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123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2903138019"/>
                  </a:ext>
                </a:extLst>
              </a:tr>
              <a:tr h="417914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</a:rPr>
                        <a:t>QNS924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Non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8.5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0.95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9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108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3811988192"/>
                  </a:ext>
                </a:extLst>
              </a:tr>
              <a:tr h="41791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MC9999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9.5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66.9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6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3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4142397796"/>
                  </a:ext>
                </a:extLst>
              </a:tr>
              <a:tr h="417914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</a:rPr>
                        <a:t>QNS1065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Non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9.3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0.84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3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152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1139329659"/>
                  </a:ext>
                </a:extLst>
              </a:tr>
              <a:tr h="41791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MC9999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9.3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56.7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4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129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3757040126"/>
                  </a:ext>
                </a:extLst>
              </a:tr>
              <a:tr h="417914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</a:rPr>
                        <a:t>QNS1070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Non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6.8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0.78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5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0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4161948024"/>
                  </a:ext>
                </a:extLst>
              </a:tr>
              <a:tr h="41791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MC9999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96.5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42.0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86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71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2456773375"/>
                  </a:ext>
                </a:extLst>
              </a:tr>
              <a:tr h="417914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QNS871</a:t>
                      </a: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Non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7</a:t>
                      </a: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2802676265"/>
                  </a:ext>
                </a:extLst>
              </a:tr>
              <a:tr h="417914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MC9999 CAR-T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4</a:t>
                      </a: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1</a:t>
                      </a: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</a:p>
                  </a:txBody>
                  <a:tcPr marL="89046" marR="89046" marT="44523" marB="4452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89046" marR="89046" marT="44523" marB="44523"/>
                </a:tc>
                <a:extLst>
                  <a:ext uri="{0D108BD9-81ED-4DB2-BD59-A6C34878D82A}">
                    <a16:rowId xmlns:a16="http://schemas.microsoft.com/office/drawing/2014/main" val="199270983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9F80F7D-9AEE-8F8E-1578-8AB3F48C1515}"/>
              </a:ext>
            </a:extLst>
          </p:cNvPr>
          <p:cNvSpPr txBox="1"/>
          <p:nvPr/>
        </p:nvSpPr>
        <p:spPr>
          <a:xfrm>
            <a:off x="307074" y="688368"/>
            <a:ext cx="7078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: QC analysis for patient derived CAR T cells</a:t>
            </a:r>
          </a:p>
        </p:txBody>
      </p:sp>
    </p:spTree>
    <p:extLst>
      <p:ext uri="{BB962C8B-B14F-4D97-AF65-F5344CB8AC3E}">
        <p14:creationId xmlns:p14="http://schemas.microsoft.com/office/powerpoint/2010/main" val="942168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8</TotalTime>
  <Words>116</Words>
  <Application>Microsoft Office PowerPoint</Application>
  <PresentationFormat>Custom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Ulloa Navas, Maria J., Ph.D., M.S.</dc:creator>
  <cp:lastModifiedBy>Ulloa Navas, Maria J., Ph.D., M.S.</cp:lastModifiedBy>
  <cp:revision>64</cp:revision>
  <dcterms:created xsi:type="dcterms:W3CDTF">2024-09-02T16:12:58Z</dcterms:created>
  <dcterms:modified xsi:type="dcterms:W3CDTF">2024-11-22T20:13:50Z</dcterms:modified>
</cp:coreProperties>
</file>